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73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4" d="100"/>
          <a:sy n="74" d="100"/>
        </p:scale>
        <p:origin x="15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9344420"/>
              </p:ext>
            </p:extLst>
          </p:nvPr>
        </p:nvGraphicFramePr>
        <p:xfrm>
          <a:off x="140493" y="1168489"/>
          <a:ext cx="6400799" cy="274320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4457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3452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345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86566">
                <a:tc>
                  <a:txBody>
                    <a:bodyPr/>
                    <a:lstStyle/>
                    <a:p>
                      <a:pPr marL="0" marR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/>
                      </a:pPr>
                      <a:endParaRPr lang="fr-FR" sz="1200" b="0" i="0" u="none" strike="noStrike" kern="1200" cap="none" dirty="0">
                        <a:ln>
                          <a:noFill/>
                        </a:ln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-squared</a:t>
                      </a:r>
                      <a:r>
                        <a:rPr lang="en-US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rom linear regression between both RNA-Seq biological replicates in </a:t>
                      </a:r>
                      <a:r>
                        <a:rPr lang="en-US" sz="1200" i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b</a:t>
                      </a:r>
                      <a:endParaRPr lang="en-US" sz="12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+mn-lt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-squared</a:t>
                      </a:r>
                      <a:r>
                        <a:rPr lang="en-US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rom linear regression between both RNA-Seq biological replicates in </a:t>
                      </a:r>
                      <a:r>
                        <a:rPr lang="en-US" sz="1200" i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  <a:endParaRPr lang="en-US" sz="12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 post-inoculation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SSI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MSI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SSI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MSI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9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7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8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4570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.94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7B0E489D-8753-3ABE-C26F-F8EC124853CF}"/>
              </a:ext>
            </a:extLst>
          </p:cNvPr>
          <p:cNvSpPr txBox="1"/>
          <p:nvPr/>
        </p:nvSpPr>
        <p:spPr>
          <a:xfrm>
            <a:off x="140493" y="4025290"/>
            <a:ext cx="6400799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were measured by a linear regression applied on raw gene expression of Lmb or Lbb. The R-squared (ranging from 0 to 1) between replicates of each sampled date is displayed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F5169E2-0CCB-EAF0-9D57-11343AC08CD0}"/>
              </a:ext>
            </a:extLst>
          </p:cNvPr>
          <p:cNvSpPr txBox="1"/>
          <p:nvPr/>
        </p:nvSpPr>
        <p:spPr>
          <a:xfrm>
            <a:off x="140493" y="454724"/>
            <a:ext cx="6400799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8, Table S3. Correlation of gene expression between biological replicates following Single Species Inoculation of cotyledons of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 napus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mb),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bb)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following Mixed Species Inoculation of Lmb and Lbb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95794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143</Words>
  <Application>Microsoft Office PowerPoint</Application>
  <PresentationFormat>A4 Paper (210x297 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77</cp:revision>
  <dcterms:created xsi:type="dcterms:W3CDTF">2020-02-06T09:05:41Z</dcterms:created>
  <dcterms:modified xsi:type="dcterms:W3CDTF">2023-10-05T10:49:33Z</dcterms:modified>
</cp:coreProperties>
</file>